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>
      <p:cViewPr varScale="1">
        <p:scale>
          <a:sx n="87" d="100"/>
          <a:sy n="87" d="100"/>
        </p:scale>
        <p:origin x="3432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D0DEF-AD05-5C49-9CB6-85B980DAC1A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1B874B-B9C3-8847-8AA9-9668C45DD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97427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D0DEF-AD05-5C49-9CB6-85B980DAC1A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1B874B-B9C3-8847-8AA9-9668C45DD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62014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D0DEF-AD05-5C49-9CB6-85B980DAC1A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1B874B-B9C3-8847-8AA9-9668C45DD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51143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D0DEF-AD05-5C49-9CB6-85B980DAC1A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1B874B-B9C3-8847-8AA9-9668C45DD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56125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D0DEF-AD05-5C49-9CB6-85B980DAC1A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1B874B-B9C3-8847-8AA9-9668C45DD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50312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D0DEF-AD05-5C49-9CB6-85B980DAC1A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1B874B-B9C3-8847-8AA9-9668C45DD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65502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D0DEF-AD05-5C49-9CB6-85B980DAC1A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1B874B-B9C3-8847-8AA9-9668C45DD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76618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D0DEF-AD05-5C49-9CB6-85B980DAC1A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1B874B-B9C3-8847-8AA9-9668C45DD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65941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D0DEF-AD05-5C49-9CB6-85B980DAC1A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1B874B-B9C3-8847-8AA9-9668C45DD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32459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D0DEF-AD05-5C49-9CB6-85B980DAC1A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1B874B-B9C3-8847-8AA9-9668C45DD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33051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D0DEF-AD05-5C49-9CB6-85B980DAC1A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1B874B-B9C3-8847-8AA9-9668C45DD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40174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C3D0DEF-AD05-5C49-9CB6-85B980DAC1A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F1B874B-B9C3-8847-8AA9-9668C45DD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38482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1D23350A-FCB7-549F-46E5-153787FE736A}"/>
              </a:ext>
            </a:extLst>
          </p:cNvPr>
          <p:cNvSpPr txBox="1"/>
          <p:nvPr/>
        </p:nvSpPr>
        <p:spPr>
          <a:xfrm>
            <a:off x="974445" y="2558450"/>
            <a:ext cx="5013399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Data availability</a:t>
            </a:r>
            <a:endParaRPr lang="en-US" altLang="en-US" sz="1200" dirty="0"/>
          </a:p>
          <a:p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The </a:t>
            </a:r>
            <a:r>
              <a:rPr kumimoji="0" lang="en-US" altLang="en-US" sz="12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scRNA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-seq data have been deposited in the GEO database under accession code GSE275858. Additional information and/or reagents are available from the authors on request. </a:t>
            </a:r>
            <a:endParaRPr lang="en-US" sz="120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65B9D8D-1EEE-8643-7D32-DB23C6E72D6D}"/>
              </a:ext>
            </a:extLst>
          </p:cNvPr>
          <p:cNvSpPr txBox="1"/>
          <p:nvPr/>
        </p:nvSpPr>
        <p:spPr>
          <a:xfrm>
            <a:off x="530942" y="825908"/>
            <a:ext cx="514718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4F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Expression of a subset of genes in the Tumor cells within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iKRAS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and STAT3KO tumors +Dox and following Dox removal for 4 days</a:t>
            </a:r>
          </a:p>
        </p:txBody>
      </p:sp>
    </p:spTree>
    <p:extLst>
      <p:ext uri="{BB962C8B-B14F-4D97-AF65-F5344CB8AC3E}">
        <p14:creationId xmlns:p14="http://schemas.microsoft.com/office/powerpoint/2010/main" val="15485616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</TotalTime>
  <Words>57</Words>
  <Application>Microsoft Macintosh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Nancy Reich Marshall</dc:creator>
  <cp:lastModifiedBy>Nancy Reich Marshall</cp:lastModifiedBy>
  <cp:revision>5</cp:revision>
  <dcterms:created xsi:type="dcterms:W3CDTF">2025-06-10T18:50:08Z</dcterms:created>
  <dcterms:modified xsi:type="dcterms:W3CDTF">2025-06-10T19:08:40Z</dcterms:modified>
</cp:coreProperties>
</file>